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  <p:sldId id="257" r:id="rId5"/>
    <p:sldId id="258" r:id="rId6"/>
    <p:sldId id="259" r:id="rId7"/>
    <p:sldId id="260" r:id="rId8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2CD0A4-4701-4C2B-A44B-B6F460F4CB1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E8D3A7-AEFC-4F98-8DAB-44E3A50CCE6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5D6EB2-36F0-4C97-9459-D57E85CBDF5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0BBAB9-BBB1-4102-B388-A8ACBE9F45D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70DDAC9-6649-4917-B441-7E3897336B8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EFFA4BF-4BB3-4F5D-B7FF-A98B817D34D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280C022-7E35-4FED-B2B5-2D0E955C7A4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8C1CCCF-D7C9-4DA5-80F3-9E33509B50B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C72C9B3-3164-43C7-8D71-4ADAC3E9A90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F2E0BF5-A54F-4D3A-AA50-EF94133D8B2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F3B760B-8161-4E19-AF69-19639DFBD9B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F64AB8-8042-431D-BAE6-3EB56832C05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E587BAE-8B9A-4C27-BEEA-6CC34A73F9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029803E-AECE-4D4F-AA94-014D5B5F10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CD4E357-6DDE-497F-9384-59592428BF4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D0A123E-018E-452D-AC6F-D000B75DBDB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059119C-0803-44A0-B5D4-072648C632C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49D6A3-1442-411F-8768-4400E805367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036A9E-E389-4047-AD40-933D9666AD2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703BD0-35B1-4055-ACB9-5C647DE97E8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3BF58F-EDD0-4C8B-B23D-E45F049152F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381FF3-B1A4-4A49-826E-CDC7ABBF333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5FC230-0CA2-4E70-887C-65B31A405C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B819FB-1093-4A42-9326-5D4BC970CC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8C940EF-FAF5-4F53-A79E-29AE0516D542}" type="slidenum"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FD498C8-28A7-4D47-B904-E511260B948E}" type="datetime"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26/8/29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02C889D-1F32-4452-A1CB-D4925A45B053}" type="slidenum"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hyperlink" Target="file:///G:%5C1111%5CF13FTSNCKF1177_SALybmT%5CF13FTSNCKF1177_SALybmT%5CF13FTSNCKF1177_SALybmT%5Cannotation%5CKEGG%5CAll-Unigene.fa.htm#gene1" TargetMode="External"/><Relationship Id="rId2" Type="http://schemas.openxmlformats.org/officeDocument/2006/relationships/hyperlink" Target="file:///G:%5C1111%5CF13FTSNCKF1177_SALybmT%5CF13FTSNCKF1177_SALybmT%5CF13FTSNCKF1177_SALybmT%5Cannotation%5CKEGG%5CAll-Unigene.fa.htm#gene2" TargetMode="External"/><Relationship Id="rId3" Type="http://schemas.openxmlformats.org/officeDocument/2006/relationships/hyperlink" Target="file:///G:%5C1111%5CF13FTSNCKF1177_SALybmT%5CF13FTSNCKF1177_SALybmT%5CF13FTSNCKF1177_SALybmT%5Cannotation%5CKEGG%5CAll-Unigene.fa.htm#gene3" TargetMode="External"/><Relationship Id="rId4" Type="http://schemas.openxmlformats.org/officeDocument/2006/relationships/hyperlink" Target="file:///G:%5C1111%5CF13FTSNCKF1177_SALybmT%5CF13FTSNCKF1177_SALybmT%5CF13FTSNCKF1177_SALybmT%5Cannotation%5CKEGG%5CAll-Unigene.fa.htm#gene4" TargetMode="External"/><Relationship Id="rId5" Type="http://schemas.openxmlformats.org/officeDocument/2006/relationships/hyperlink" Target="file:///G:%5C1111%5CF13FTSNCKF1177_SALybmT%5CF13FTSNCKF1177_SALybmT%5CF13FTSNCKF1177_SALybmT%5Cannotation%5CKEGG%5CAll-Unigene.fa.htm#gene5" TargetMode="External"/><Relationship Id="rId6" Type="http://schemas.openxmlformats.org/officeDocument/2006/relationships/hyperlink" Target="file:///G:%5C1111%5CF13FTSNCKF1177_SALybmT%5CF13FTSNCKF1177_SALybmT%5CF13FTSNCKF1177_SALybmT%5Cannotation%5CKEGG%5CAll-Unigene.fa.htm#gene6" TargetMode="External"/><Relationship Id="rId7" Type="http://schemas.openxmlformats.org/officeDocument/2006/relationships/hyperlink" Target="file:///G:%5C1111%5CF13FTSNCKF1177_SALybmT%5CF13FTSNCKF1177_SALybmT%5CF13FTSNCKF1177_SALybmT%5Cannotation%5CKEGG%5CAll-Unigene.fa.htm#gene7" TargetMode="External"/><Relationship Id="rId8" Type="http://schemas.openxmlformats.org/officeDocument/2006/relationships/hyperlink" Target="file:///G:%5C1111%5CF13FTSNCKF1177_SALybmT%5CF13FTSNCKF1177_SALybmT%5CF13FTSNCKF1177_SALybmT%5Cannotation%5CKEGG%5CAll-Unigene.fa.htm#gene8" TargetMode="External"/><Relationship Id="rId9" Type="http://schemas.openxmlformats.org/officeDocument/2006/relationships/hyperlink" Target="file:///G:%5C1111%5CF13FTSNCKF1177_SALybmT%5CF13FTSNCKF1177_SALybmT%5CF13FTSNCKF1177_SALybmT%5Cannotation%5CKEGG%5CAll-Unigene.fa.htm#gene9" TargetMode="External"/><Relationship Id="rId10" Type="http://schemas.openxmlformats.org/officeDocument/2006/relationships/hyperlink" Target="file:///G:%5C1111%5CF13FTSNCKF1177_SALybmT%5CF13FTSNCKF1177_SALybmT%5CF13FTSNCKF1177_SALybmT%5Cannotation%5CKEGG%5CAll-Unigene.fa.htm#gene10" TargetMode="External"/><Relationship Id="rId11" Type="http://schemas.openxmlformats.org/officeDocument/2006/relationships/hyperlink" Target="file:///G:%5C1111%5CF13FTSNCKF1177_SALybmT%5CF13FTSNCKF1177_SALybmT%5CF13FTSNCKF1177_SALybmT%5Cannotation%5CKEGG%5CAll-Unigene.fa.htm#gene11" TargetMode="External"/><Relationship Id="rId12" Type="http://schemas.openxmlformats.org/officeDocument/2006/relationships/hyperlink" Target="file:///G:%5C1111%5CF13FTSNCKF1177_SALybmT%5CF13FTSNCKF1177_SALybmT%5CF13FTSNCKF1177_SALybmT%5Cannotation%5CKEGG%5CAll-Unigene.fa.htm#gene12" TargetMode="External"/><Relationship Id="rId13" Type="http://schemas.openxmlformats.org/officeDocument/2006/relationships/hyperlink" Target="file:///G:%5C1111%5CF13FTSNCKF1177_SALybmT%5CF13FTSNCKF1177_SALybmT%5CF13FTSNCKF1177_SALybmT%5Cannotation%5CKEGG%5CAll-Unigene.fa.htm#gene13" TargetMode="External"/><Relationship Id="rId14" Type="http://schemas.openxmlformats.org/officeDocument/2006/relationships/hyperlink" Target="file:///G:%5C1111%5CF13FTSNCKF1177_SALybmT%5CF13FTSNCKF1177_SALybmT%5CF13FTSNCKF1177_SALybmT%5Cannotation%5CKEGG%5CAll-Unigene.fa.htm#gene14" TargetMode="External"/><Relationship Id="rId15" Type="http://schemas.openxmlformats.org/officeDocument/2006/relationships/hyperlink" Target="file:///G:%5C1111%5CF13FTSNCKF1177_SALybmT%5CF13FTSNCKF1177_SALybmT%5CF13FTSNCKF1177_SALybmT%5Cannotation%5CKEGG%5CAll-Unigene.fa.htm#gene15" TargetMode="External"/><Relationship Id="rId16" Type="http://schemas.openxmlformats.org/officeDocument/2006/relationships/hyperlink" Target="file:///G:%5C1111%5CF13FTSNCKF1177_SALybmT%5CF13FTSNCKF1177_SALybmT%5CF13FTSNCKF1177_SALybmT%5Cannotation%5CKEGG%5CAll-Unigene.fa.htm#gene16" TargetMode="External"/><Relationship Id="rId17" Type="http://schemas.openxmlformats.org/officeDocument/2006/relationships/hyperlink" Target="file:///G:%5C1111%5CF13FTSNCKF1177_SALybmT%5CF13FTSNCKF1177_SALybmT%5CF13FTSNCKF1177_SALybmT%5Cannotation%5CKEGG%5CAll-Unigene.fa.htm#gene17" TargetMode="External"/><Relationship Id="rId18" Type="http://schemas.openxmlformats.org/officeDocument/2006/relationships/hyperlink" Target="file:///G:%5C1111%5CF13FTSNCKF1177_SALybmT%5CF13FTSNCKF1177_SALybmT%5CF13FTSNCKF1177_SALybmT%5Cannotation%5CKEGG%5CAll-Unigene.fa.htm#gene18" TargetMode="External"/><Relationship Id="rId19" Type="http://schemas.openxmlformats.org/officeDocument/2006/relationships/hyperlink" Target="file:///G:%5C1111%5CF13FTSNCKF1177_SALybmT%5CF13FTSNCKF1177_SALybmT%5CF13FTSNCKF1177_SALybmT%5Cannotation%5CKEGG%5CAll-Unigene.fa.htm#gene19" TargetMode="External"/><Relationship Id="rId20" Type="http://schemas.openxmlformats.org/officeDocument/2006/relationships/hyperlink" Target="file:///G:%5C1111%5CF13FTSNCKF1177_SALybmT%5CF13FTSNCKF1177_SALybmT%5CF13FTSNCKF1177_SALybmT%5Cannotation%5CKEGG%5CAll-Unigene.fa.htm#gene20" TargetMode="External"/><Relationship Id="rId21" Type="http://schemas.openxmlformats.org/officeDocument/2006/relationships/hyperlink" Target="file:///G:%5C1111%5CF13FTSNCKF1177_SALybmT%5CF13FTSNCKF1177_SALybmT%5CF13FTSNCKF1177_SALybmT%5Cannotation%5CKEGG%5CAll-Unigene.fa.htm#gene21" TargetMode="External"/><Relationship Id="rId22" Type="http://schemas.openxmlformats.org/officeDocument/2006/relationships/hyperlink" Target="file:///G:%5C1111%5CF13FTSNCKF1177_SALybmT%5CF13FTSNCKF1177_SALybmT%5CF13FTSNCKF1177_SALybmT%5Cannotation%5CKEGG%5CAll-Unigene.fa.htm#gene22" TargetMode="External"/><Relationship Id="rId23" Type="http://schemas.openxmlformats.org/officeDocument/2006/relationships/hyperlink" Target="file:///G:%5C1111%5CF13FTSNCKF1177_SALybmT%5CF13FTSNCKF1177_SALybmT%5CF13FTSNCKF1177_SALybmT%5Cannotation%5CKEGG%5CAll-Unigene.fa.htm#gene23" TargetMode="External"/><Relationship Id="rId24" Type="http://schemas.openxmlformats.org/officeDocument/2006/relationships/hyperlink" Target="file:///G:%5C1111%5CF13FTSNCKF1177_SALybmT%5CF13FTSNCKF1177_SALybmT%5CF13FTSNCKF1177_SALybmT%5Cannotation%5CKEGG%5CAll-Unigene.fa.htm#gene24" TargetMode="External"/><Relationship Id="rId25" Type="http://schemas.openxmlformats.org/officeDocument/2006/relationships/slideLayout" Target="../slideLayouts/slideLayout1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hyperlink" Target="file:///G:%5C1111%5CF13FTSNCKF1177_SALybmT%5CF13FTSNCKF1177_SALybmT%5CF13FTSNCKF1177_SALybmT%5Cannotation%5CKEGG%5CAll-Unigene.fa.htm#gene25" TargetMode="External"/><Relationship Id="rId2" Type="http://schemas.openxmlformats.org/officeDocument/2006/relationships/hyperlink" Target="file:///G:%5C1111%5CF13FTSNCKF1177_SALybmT%5CF13FTSNCKF1177_SALybmT%5CF13FTSNCKF1177_SALybmT%5Cannotation%5CKEGG%5CAll-Unigene.fa.htm#gene26" TargetMode="External"/><Relationship Id="rId3" Type="http://schemas.openxmlformats.org/officeDocument/2006/relationships/hyperlink" Target="file:///G:%5C1111%5CF13FTSNCKF1177_SALybmT%5CF13FTSNCKF1177_SALybmT%5CF13FTSNCKF1177_SALybmT%5Cannotation%5CKEGG%5CAll-Unigene.fa.htm#gene27" TargetMode="External"/><Relationship Id="rId4" Type="http://schemas.openxmlformats.org/officeDocument/2006/relationships/hyperlink" Target="file:///G:%5C1111%5CF13FTSNCKF1177_SALybmT%5CF13FTSNCKF1177_SALybmT%5CF13FTSNCKF1177_SALybmT%5Cannotation%5CKEGG%5CAll-Unigene.fa.htm#gene28" TargetMode="External"/><Relationship Id="rId5" Type="http://schemas.openxmlformats.org/officeDocument/2006/relationships/hyperlink" Target="file:///G:%5C1111%5CF13FTSNCKF1177_SALybmT%5CF13FTSNCKF1177_SALybmT%5CF13FTSNCKF1177_SALybmT%5Cannotation%5CKEGG%5CAll-Unigene.fa.htm#gene29" TargetMode="External"/><Relationship Id="rId6" Type="http://schemas.openxmlformats.org/officeDocument/2006/relationships/hyperlink" Target="file:///G:%5C1111%5CF13FTSNCKF1177_SALybmT%5CF13FTSNCKF1177_SALybmT%5CF13FTSNCKF1177_SALybmT%5Cannotation%5CKEGG%5CAll-Unigene.fa.htm#gene30" TargetMode="External"/><Relationship Id="rId7" Type="http://schemas.openxmlformats.org/officeDocument/2006/relationships/hyperlink" Target="file:///G:%5C1111%5CF13FTSNCKF1177_SALybmT%5CF13FTSNCKF1177_SALybmT%5CF13FTSNCKF1177_SALybmT%5Cannotation%5CKEGG%5CAll-Unigene.fa.htm#gene31" TargetMode="External"/><Relationship Id="rId8" Type="http://schemas.openxmlformats.org/officeDocument/2006/relationships/hyperlink" Target="file:///G:%5C1111%5CF13FTSNCKF1177_SALybmT%5CF13FTSNCKF1177_SALybmT%5CF13FTSNCKF1177_SALybmT%5Cannotation%5CKEGG%5CAll-Unigene.fa.htm#gene32" TargetMode="External"/><Relationship Id="rId9" Type="http://schemas.openxmlformats.org/officeDocument/2006/relationships/hyperlink" Target="file:///G:%5C1111%5CF13FTSNCKF1177_SALybmT%5CF13FTSNCKF1177_SALybmT%5CF13FTSNCKF1177_SALybmT%5Cannotation%5CKEGG%5CAll-Unigene.fa.htm#gene33" TargetMode="External"/><Relationship Id="rId10" Type="http://schemas.openxmlformats.org/officeDocument/2006/relationships/hyperlink" Target="file:///G:%5C1111%5CF13FTSNCKF1177_SALybmT%5CF13FTSNCKF1177_SALybmT%5CF13FTSNCKF1177_SALybmT%5Cannotation%5CKEGG%5CAll-Unigene.fa.htm#gene34" TargetMode="External"/><Relationship Id="rId11" Type="http://schemas.openxmlformats.org/officeDocument/2006/relationships/hyperlink" Target="file:///G:%5C1111%5CF13FTSNCKF1177_SALybmT%5CF13FTSNCKF1177_SALybmT%5CF13FTSNCKF1177_SALybmT%5Cannotation%5CKEGG%5CAll-Unigene.fa.htm#gene35" TargetMode="External"/><Relationship Id="rId12" Type="http://schemas.openxmlformats.org/officeDocument/2006/relationships/hyperlink" Target="file:///G:%5C1111%5CF13FTSNCKF1177_SALybmT%5CF13FTSNCKF1177_SALybmT%5CF13FTSNCKF1177_SALybmT%5Cannotation%5CKEGG%5CAll-Unigene.fa.htm#gene36" TargetMode="External"/><Relationship Id="rId13" Type="http://schemas.openxmlformats.org/officeDocument/2006/relationships/hyperlink" Target="file:///G:%5C1111%5CF13FTSNCKF1177_SALybmT%5CF13FTSNCKF1177_SALybmT%5CF13FTSNCKF1177_SALybmT%5Cannotation%5CKEGG%5CAll-Unigene.fa.htm#gene37" TargetMode="External"/><Relationship Id="rId14" Type="http://schemas.openxmlformats.org/officeDocument/2006/relationships/hyperlink" Target="file:///G:%5C1111%5CF13FTSNCKF1177_SALybmT%5CF13FTSNCKF1177_SALybmT%5CF13FTSNCKF1177_SALybmT%5Cannotation%5CKEGG%5CAll-Unigene.fa.htm#gene38" TargetMode="External"/><Relationship Id="rId15" Type="http://schemas.openxmlformats.org/officeDocument/2006/relationships/hyperlink" Target="file:///G:%5C1111%5CF13FTSNCKF1177_SALybmT%5CF13FTSNCKF1177_SALybmT%5CF13FTSNCKF1177_SALybmT%5Cannotation%5CKEGG%5CAll-Unigene.fa.htm#gene39" TargetMode="External"/><Relationship Id="rId16" Type="http://schemas.openxmlformats.org/officeDocument/2006/relationships/hyperlink" Target="file:///G:%5C1111%5CF13FTSNCKF1177_SALybmT%5CF13FTSNCKF1177_SALybmT%5CF13FTSNCKF1177_SALybmT%5Cannotation%5CKEGG%5CAll-Unigene.fa.htm#gene40" TargetMode="External"/><Relationship Id="rId17" Type="http://schemas.openxmlformats.org/officeDocument/2006/relationships/hyperlink" Target="file:///G:%5C1111%5CF13FTSNCKF1177_SALybmT%5CF13FTSNCKF1177_SALybmT%5CF13FTSNCKF1177_SALybmT%5Cannotation%5CKEGG%5CAll-Unigene.fa.htm#gene41" TargetMode="External"/><Relationship Id="rId18" Type="http://schemas.openxmlformats.org/officeDocument/2006/relationships/hyperlink" Target="file:///G:%5C1111%5CF13FTSNCKF1177_SALybmT%5CF13FTSNCKF1177_SALybmT%5CF13FTSNCKF1177_SALybmT%5Cannotation%5CKEGG%5CAll-Unigene.fa.htm#gene42" TargetMode="External"/><Relationship Id="rId19" Type="http://schemas.openxmlformats.org/officeDocument/2006/relationships/hyperlink" Target="file:///G:%5C1111%5CF13FTSNCKF1177_SALybmT%5CF13FTSNCKF1177_SALybmT%5CF13FTSNCKF1177_SALybmT%5Cannotation%5CKEGG%5CAll-Unigene.fa.htm#gene43" TargetMode="External"/><Relationship Id="rId20" Type="http://schemas.openxmlformats.org/officeDocument/2006/relationships/hyperlink" Target="file:///G:%5C1111%5CF13FTSNCKF1177_SALybmT%5CF13FTSNCKF1177_SALybmT%5CF13FTSNCKF1177_SALybmT%5Cannotation%5CKEGG%5CAll-Unigene.fa.htm#gene44" TargetMode="External"/><Relationship Id="rId21" Type="http://schemas.openxmlformats.org/officeDocument/2006/relationships/hyperlink" Target="file:///G:%5C1111%5CF13FTSNCKF1177_SALybmT%5CF13FTSNCKF1177_SALybmT%5CF13FTSNCKF1177_SALybmT%5Cannotation%5CKEGG%5CAll-Unigene.fa.htm#gene45" TargetMode="External"/><Relationship Id="rId22" Type="http://schemas.openxmlformats.org/officeDocument/2006/relationships/hyperlink" Target="file:///G:%5C1111%5CF13FTSNCKF1177_SALybmT%5CF13FTSNCKF1177_SALybmT%5CF13FTSNCKF1177_SALybmT%5Cannotation%5CKEGG%5CAll-Unigene.fa.htm#gene46" TargetMode="External"/><Relationship Id="rId23" Type="http://schemas.openxmlformats.org/officeDocument/2006/relationships/hyperlink" Target="file:///G:%5C1111%5CF13FTSNCKF1177_SALybmT%5CF13FTSNCKF1177_SALybmT%5CF13FTSNCKF1177_SALybmT%5Cannotation%5CKEGG%5CAll-Unigene.fa.htm#gene47" TargetMode="External"/><Relationship Id="rId24" Type="http://schemas.openxmlformats.org/officeDocument/2006/relationships/hyperlink" Target="file:///G:%5C1111%5CF13FTSNCKF1177_SALybmT%5CF13FTSNCKF1177_SALybmT%5CF13FTSNCKF1177_SALybmT%5Cannotation%5CKEGG%5CAll-Unigene.fa.htm#gene48" TargetMode="External"/><Relationship Id="rId25" Type="http://schemas.openxmlformats.org/officeDocument/2006/relationships/hyperlink" Target="file:///G:%5C1111%5CF13FTSNCKF1177_SALybmT%5CF13FTSNCKF1177_SALybmT%5CF13FTSNCKF1177_SALybmT%5Cannotation%5CKEGG%5CAll-Unigene.fa.htm#gene49" TargetMode="External"/><Relationship Id="rId26" Type="http://schemas.openxmlformats.org/officeDocument/2006/relationships/hyperlink" Target="file:///G:%5C1111%5CF13FTSNCKF1177_SALybmT%5CF13FTSNCKF1177_SALybmT%5CF13FTSNCKF1177_SALybmT%5Cannotation%5CKEGG%5CAll-Unigene.fa.htm#gene50" TargetMode="External"/><Relationship Id="rId27" Type="http://schemas.openxmlformats.org/officeDocument/2006/relationships/slideLayout" Target="../slideLayouts/slideLayout1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hyperlink" Target="file:///G:%5C1111%5CF13FTSNCKF1177_SALybmT%5CF13FTSNCKF1177_SALybmT%5CF13FTSNCKF1177_SALybmT%5Cannotation%5CKEGG%5CAll-Unigene.fa.htm#gene51" TargetMode="External"/><Relationship Id="rId2" Type="http://schemas.openxmlformats.org/officeDocument/2006/relationships/hyperlink" Target="file:///G:%5C1111%5CF13FTSNCKF1177_SALybmT%5CF13FTSNCKF1177_SALybmT%5CF13FTSNCKF1177_SALybmT%5Cannotation%5CKEGG%5CAll-Unigene.fa.htm#gene52" TargetMode="External"/><Relationship Id="rId3" Type="http://schemas.openxmlformats.org/officeDocument/2006/relationships/hyperlink" Target="file:///G:%5C1111%5CF13FTSNCKF1177_SALybmT%5CF13FTSNCKF1177_SALybmT%5CF13FTSNCKF1177_SALybmT%5Cannotation%5CKEGG%5CAll-Unigene.fa.htm#gene53" TargetMode="External"/><Relationship Id="rId4" Type="http://schemas.openxmlformats.org/officeDocument/2006/relationships/hyperlink" Target="file:///G:%5C1111%5CF13FTSNCKF1177_SALybmT%5CF13FTSNCKF1177_SALybmT%5CF13FTSNCKF1177_SALybmT%5Cannotation%5CKEGG%5CAll-Unigene.fa.htm#gene54" TargetMode="External"/><Relationship Id="rId5" Type="http://schemas.openxmlformats.org/officeDocument/2006/relationships/hyperlink" Target="file:///G:%5C1111%5CF13FTSNCKF1177_SALybmT%5CF13FTSNCKF1177_SALybmT%5CF13FTSNCKF1177_SALybmT%5Cannotation%5CKEGG%5CAll-Unigene.fa.htm#gene55" TargetMode="External"/><Relationship Id="rId6" Type="http://schemas.openxmlformats.org/officeDocument/2006/relationships/hyperlink" Target="file:///G:%5C1111%5CF13FTSNCKF1177_SALybmT%5CF13FTSNCKF1177_SALybmT%5CF13FTSNCKF1177_SALybmT%5Cannotation%5CKEGG%5CAll-Unigene.fa.htm#gene56" TargetMode="External"/><Relationship Id="rId7" Type="http://schemas.openxmlformats.org/officeDocument/2006/relationships/hyperlink" Target="file:///G:%5C1111%5CF13FTSNCKF1177_SALybmT%5CF13FTSNCKF1177_SALybmT%5CF13FTSNCKF1177_SALybmT%5Cannotation%5CKEGG%5CAll-Unigene.fa.htm#gene57" TargetMode="External"/><Relationship Id="rId8" Type="http://schemas.openxmlformats.org/officeDocument/2006/relationships/hyperlink" Target="file:///G:%5C1111%5CF13FTSNCKF1177_SALybmT%5CF13FTSNCKF1177_SALybmT%5CF13FTSNCKF1177_SALybmT%5Cannotation%5CKEGG%5CAll-Unigene.fa.htm#gene58" TargetMode="External"/><Relationship Id="rId9" Type="http://schemas.openxmlformats.org/officeDocument/2006/relationships/hyperlink" Target="file:///G:%5C1111%5CF13FTSNCKF1177_SALybmT%5CF13FTSNCKF1177_SALybmT%5CF13FTSNCKF1177_SALybmT%5Cannotation%5CKEGG%5CAll-Unigene.fa.htm#gene59" TargetMode="External"/><Relationship Id="rId10" Type="http://schemas.openxmlformats.org/officeDocument/2006/relationships/hyperlink" Target="file:///G:%5C1111%5CF13FTSNCKF1177_SALybmT%5CF13FTSNCKF1177_SALybmT%5CF13FTSNCKF1177_SALybmT%5Cannotation%5CKEGG%5CAll-Unigene.fa.htm#gene60" TargetMode="External"/><Relationship Id="rId11" Type="http://schemas.openxmlformats.org/officeDocument/2006/relationships/hyperlink" Target="file:///G:%5C1111%5CF13FTSNCKF1177_SALybmT%5CF13FTSNCKF1177_SALybmT%5CF13FTSNCKF1177_SALybmT%5Cannotation%5CKEGG%5CAll-Unigene.fa.htm#gene61" TargetMode="External"/><Relationship Id="rId12" Type="http://schemas.openxmlformats.org/officeDocument/2006/relationships/hyperlink" Target="file:///G:%5C1111%5CF13FTSNCKF1177_SALybmT%5CF13FTSNCKF1177_SALybmT%5CF13FTSNCKF1177_SALybmT%5Cannotation%5CKEGG%5CAll-Unigene.fa.htm#gene62" TargetMode="External"/><Relationship Id="rId13" Type="http://schemas.openxmlformats.org/officeDocument/2006/relationships/hyperlink" Target="file:///G:%5C1111%5CF13FTSNCKF1177_SALybmT%5CF13FTSNCKF1177_SALybmT%5CF13FTSNCKF1177_SALybmT%5Cannotation%5CKEGG%5CAll-Unigene.fa.htm#gene63" TargetMode="External"/><Relationship Id="rId14" Type="http://schemas.openxmlformats.org/officeDocument/2006/relationships/hyperlink" Target="file:///G:%5C1111%5CF13FTSNCKF1177_SALybmT%5CF13FTSNCKF1177_SALybmT%5CF13FTSNCKF1177_SALybmT%5Cannotation%5CKEGG%5CAll-Unigene.fa.htm#gene64" TargetMode="External"/><Relationship Id="rId15" Type="http://schemas.openxmlformats.org/officeDocument/2006/relationships/hyperlink" Target="file:///G:%5C1111%5CF13FTSNCKF1177_SALybmT%5CF13FTSNCKF1177_SALybmT%5CF13FTSNCKF1177_SALybmT%5Cannotation%5CKEGG%5CAll-Unigene.fa.htm#gene65" TargetMode="External"/><Relationship Id="rId16" Type="http://schemas.openxmlformats.org/officeDocument/2006/relationships/hyperlink" Target="file:///G:%5C1111%5CF13FTSNCKF1177_SALybmT%5CF13FTSNCKF1177_SALybmT%5CF13FTSNCKF1177_SALybmT%5Cannotation%5CKEGG%5CAll-Unigene.fa.htm#gene66" TargetMode="External"/><Relationship Id="rId17" Type="http://schemas.openxmlformats.org/officeDocument/2006/relationships/hyperlink" Target="file:///G:%5C1111%5CF13FTSNCKF1177_SALybmT%5CF13FTSNCKF1177_SALybmT%5CF13FTSNCKF1177_SALybmT%5Cannotation%5CKEGG%5CAll-Unigene.fa.htm#gene67" TargetMode="External"/><Relationship Id="rId18" Type="http://schemas.openxmlformats.org/officeDocument/2006/relationships/hyperlink" Target="file:///G:%5C1111%5CF13FTSNCKF1177_SALybmT%5CF13FTSNCKF1177_SALybmT%5CF13FTSNCKF1177_SALybmT%5Cannotation%5CKEGG%5CAll-Unigene.fa.htm#gene68" TargetMode="External"/><Relationship Id="rId19" Type="http://schemas.openxmlformats.org/officeDocument/2006/relationships/hyperlink" Target="file:///G:%5C1111%5CF13FTSNCKF1177_SALybmT%5CF13FTSNCKF1177_SALybmT%5CF13FTSNCKF1177_SALybmT%5Cannotation%5CKEGG%5CAll-Unigene.fa.htm#gene69" TargetMode="External"/><Relationship Id="rId20" Type="http://schemas.openxmlformats.org/officeDocument/2006/relationships/hyperlink" Target="file:///G:%5C1111%5CF13FTSNCKF1177_SALybmT%5CF13FTSNCKF1177_SALybmT%5CF13FTSNCKF1177_SALybmT%5Cannotation%5CKEGG%5CAll-Unigene.fa.htm#gene70" TargetMode="External"/><Relationship Id="rId21" Type="http://schemas.openxmlformats.org/officeDocument/2006/relationships/hyperlink" Target="file:///G:%5C1111%5CF13FTSNCKF1177_SALybmT%5CF13FTSNCKF1177_SALybmT%5CF13FTSNCKF1177_SALybmT%5Cannotation%5CKEGG%5CAll-Unigene.fa.htm#gene71" TargetMode="External"/><Relationship Id="rId22" Type="http://schemas.openxmlformats.org/officeDocument/2006/relationships/hyperlink" Target="file:///G:%5C1111%5CF13FTSNCKF1177_SALybmT%5CF13FTSNCKF1177_SALybmT%5CF13FTSNCKF1177_SALybmT%5Cannotation%5CKEGG%5CAll-Unigene.fa.htm#gene72" TargetMode="External"/><Relationship Id="rId23" Type="http://schemas.openxmlformats.org/officeDocument/2006/relationships/hyperlink" Target="file:///G:%5C1111%5CF13FTSNCKF1177_SALybmT%5CF13FTSNCKF1177_SALybmT%5CF13FTSNCKF1177_SALybmT%5Cannotation%5CKEGG%5CAll-Unigene.fa.htm#gene73" TargetMode="External"/><Relationship Id="rId24" Type="http://schemas.openxmlformats.org/officeDocument/2006/relationships/hyperlink" Target="file:///G:%5C1111%5CF13FTSNCKF1177_SALybmT%5CF13FTSNCKF1177_SALybmT%5CF13FTSNCKF1177_SALybmT%5Cannotation%5CKEGG%5CAll-Unigene.fa.htm#gene74" TargetMode="External"/><Relationship Id="rId25" Type="http://schemas.openxmlformats.org/officeDocument/2006/relationships/hyperlink" Target="file:///G:%5C1111%5CF13FTSNCKF1177_SALybmT%5CF13FTSNCKF1177_SALybmT%5CF13FTSNCKF1177_SALybmT%5Cannotation%5CKEGG%5CAll-Unigene.fa.htm#gene75" TargetMode="External"/><Relationship Id="rId26" Type="http://schemas.openxmlformats.org/officeDocument/2006/relationships/slideLayout" Target="../slideLayouts/slideLayout1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hyperlink" Target="file:///G:%5C1111%5CF13FTSNCKF1177_SALybmT%5CF13FTSNCKF1177_SALybmT%5CF13FTSNCKF1177_SALybmT%5Cannotation%5CKEGG%5CAll-Unigene.fa.htm#gene76" TargetMode="External"/><Relationship Id="rId2" Type="http://schemas.openxmlformats.org/officeDocument/2006/relationships/hyperlink" Target="file:///G:%5C1111%5CF13FTSNCKF1177_SALybmT%5CF13FTSNCKF1177_SALybmT%5CF13FTSNCKF1177_SALybmT%5Cannotation%5CKEGG%5CAll-Unigene.fa.htm#gene77" TargetMode="External"/><Relationship Id="rId3" Type="http://schemas.openxmlformats.org/officeDocument/2006/relationships/hyperlink" Target="file:///G:%5C1111%5CF13FTSNCKF1177_SALybmT%5CF13FTSNCKF1177_SALybmT%5CF13FTSNCKF1177_SALybmT%5Cannotation%5CKEGG%5CAll-Unigene.fa.htm#gene78" TargetMode="External"/><Relationship Id="rId4" Type="http://schemas.openxmlformats.org/officeDocument/2006/relationships/hyperlink" Target="file:///G:%5C1111%5CF13FTSNCKF1177_SALybmT%5CF13FTSNCKF1177_SALybmT%5CF13FTSNCKF1177_SALybmT%5Cannotation%5CKEGG%5CAll-Unigene.fa.htm#gene79" TargetMode="External"/><Relationship Id="rId5" Type="http://schemas.openxmlformats.org/officeDocument/2006/relationships/hyperlink" Target="file:///G:%5C1111%5CF13FTSNCKF1177_SALybmT%5CF13FTSNCKF1177_SALybmT%5CF13FTSNCKF1177_SALybmT%5Cannotation%5CKEGG%5CAll-Unigene.fa.htm#gene80" TargetMode="External"/><Relationship Id="rId6" Type="http://schemas.openxmlformats.org/officeDocument/2006/relationships/hyperlink" Target="file:///G:%5C1111%5CF13FTSNCKF1177_SALybmT%5CF13FTSNCKF1177_SALybmT%5CF13FTSNCKF1177_SALybmT%5Cannotation%5CKEGG%5CAll-Unigene.fa.htm#gene81" TargetMode="External"/><Relationship Id="rId7" Type="http://schemas.openxmlformats.org/officeDocument/2006/relationships/hyperlink" Target="file:///G:%5C1111%5CF13FTSNCKF1177_SALybmT%5CF13FTSNCKF1177_SALybmT%5CF13FTSNCKF1177_SALybmT%5Cannotation%5CKEGG%5CAll-Unigene.fa.htm#gene82" TargetMode="External"/><Relationship Id="rId8" Type="http://schemas.openxmlformats.org/officeDocument/2006/relationships/hyperlink" Target="file:///G:%5C1111%5CF13FTSNCKF1177_SALybmT%5CF13FTSNCKF1177_SALybmT%5CF13FTSNCKF1177_SALybmT%5Cannotation%5CKEGG%5CAll-Unigene.fa.htm#gene83" TargetMode="External"/><Relationship Id="rId9" Type="http://schemas.openxmlformats.org/officeDocument/2006/relationships/hyperlink" Target="file:///G:%5C1111%5CF13FTSNCKF1177_SALybmT%5CF13FTSNCKF1177_SALybmT%5CF13FTSNCKF1177_SALybmT%5Cannotation%5CKEGG%5CAll-Unigene.fa.htm#gene84" TargetMode="External"/><Relationship Id="rId10" Type="http://schemas.openxmlformats.org/officeDocument/2006/relationships/hyperlink" Target="file:///G:%5C1111%5CF13FTSNCKF1177_SALybmT%5CF13FTSNCKF1177_SALybmT%5CF13FTSNCKF1177_SALybmT%5Cannotation%5CKEGG%5CAll-Unigene.fa.htm#gene85" TargetMode="External"/><Relationship Id="rId11" Type="http://schemas.openxmlformats.org/officeDocument/2006/relationships/hyperlink" Target="file:///G:%5C1111%5CF13FTSNCKF1177_SALybmT%5CF13FTSNCKF1177_SALybmT%5CF13FTSNCKF1177_SALybmT%5Cannotation%5CKEGG%5CAll-Unigene.fa.htm#gene86" TargetMode="External"/><Relationship Id="rId12" Type="http://schemas.openxmlformats.org/officeDocument/2006/relationships/hyperlink" Target="file:///G:%5C1111%5CF13FTSNCKF1177_SALybmT%5CF13FTSNCKF1177_SALybmT%5CF13FTSNCKF1177_SALybmT%5Cannotation%5CKEGG%5CAll-Unigene.fa.htm#gene87" TargetMode="External"/><Relationship Id="rId13" Type="http://schemas.openxmlformats.org/officeDocument/2006/relationships/hyperlink" Target="file:///G:%5C1111%5CF13FTSNCKF1177_SALybmT%5CF13FTSNCKF1177_SALybmT%5CF13FTSNCKF1177_SALybmT%5Cannotation%5CKEGG%5CAll-Unigene.fa.htm#gene88" TargetMode="External"/><Relationship Id="rId14" Type="http://schemas.openxmlformats.org/officeDocument/2006/relationships/hyperlink" Target="file:///G:%5C1111%5CF13FTSNCKF1177_SALybmT%5CF13FTSNCKF1177_SALybmT%5CF13FTSNCKF1177_SALybmT%5Cannotation%5CKEGG%5CAll-Unigene.fa.htm#gene89" TargetMode="External"/><Relationship Id="rId15" Type="http://schemas.openxmlformats.org/officeDocument/2006/relationships/hyperlink" Target="file:///G:%5C1111%5CF13FTSNCKF1177_SALybmT%5CF13FTSNCKF1177_SALybmT%5CF13FTSNCKF1177_SALybmT%5Cannotation%5CKEGG%5CAll-Unigene.fa.htm#gene90" TargetMode="External"/><Relationship Id="rId16" Type="http://schemas.openxmlformats.org/officeDocument/2006/relationships/hyperlink" Target="file:///G:%5C1111%5CF13FTSNCKF1177_SALybmT%5CF13FTSNCKF1177_SALybmT%5CF13FTSNCKF1177_SALybmT%5Cannotation%5CKEGG%5CAll-Unigene.fa.htm#gene91" TargetMode="External"/><Relationship Id="rId17" Type="http://schemas.openxmlformats.org/officeDocument/2006/relationships/hyperlink" Target="file:///G:%5C1111%5CF13FTSNCKF1177_SALybmT%5CF13FTSNCKF1177_SALybmT%5CF13FTSNCKF1177_SALybmT%5Cannotation%5CKEGG%5CAll-Unigene.fa.htm#gene92" TargetMode="External"/><Relationship Id="rId18" Type="http://schemas.openxmlformats.org/officeDocument/2006/relationships/hyperlink" Target="file:///G:%5C1111%5CF13FTSNCKF1177_SALybmT%5CF13FTSNCKF1177_SALybmT%5CF13FTSNCKF1177_SALybmT%5Cannotation%5CKEGG%5CAll-Unigene.fa.htm#gene93" TargetMode="External"/><Relationship Id="rId19" Type="http://schemas.openxmlformats.org/officeDocument/2006/relationships/hyperlink" Target="file:///G:%5C1111%5CF13FTSNCKF1177_SALybmT%5CF13FTSNCKF1177_SALybmT%5CF13FTSNCKF1177_SALybmT%5Cannotation%5CKEGG%5CAll-Unigene.fa.htm#gene94" TargetMode="External"/><Relationship Id="rId20" Type="http://schemas.openxmlformats.org/officeDocument/2006/relationships/hyperlink" Target="file:///G:%5C1111%5CF13FTSNCKF1177_SALybmT%5CF13FTSNCKF1177_SALybmT%5CF13FTSNCKF1177_SALybmT%5Cannotation%5CKEGG%5CAll-Unigene.fa.htm#gene95" TargetMode="External"/><Relationship Id="rId21" Type="http://schemas.openxmlformats.org/officeDocument/2006/relationships/hyperlink" Target="file:///G:%5C1111%5CF13FTSNCKF1177_SALybmT%5CF13FTSNCKF1177_SALybmT%5CF13FTSNCKF1177_SALybmT%5Cannotation%5CKEGG%5CAll-Unigene.fa.htm#gene96" TargetMode="External"/><Relationship Id="rId22" Type="http://schemas.openxmlformats.org/officeDocument/2006/relationships/hyperlink" Target="file:///G:%5C1111%5CF13FTSNCKF1177_SALybmT%5CF13FTSNCKF1177_SALybmT%5CF13FTSNCKF1177_SALybmT%5Cannotation%5CKEGG%5CAll-Unigene.fa.htm#gene97" TargetMode="External"/><Relationship Id="rId23" Type="http://schemas.openxmlformats.org/officeDocument/2006/relationships/hyperlink" Target="file:///G:%5C1111%5CF13FTSNCKF1177_SALybmT%5CF13FTSNCKF1177_SALybmT%5CF13FTSNCKF1177_SALybmT%5Cannotation%5CKEGG%5CAll-Unigene.fa.htm#gene98" TargetMode="External"/><Relationship Id="rId24" Type="http://schemas.openxmlformats.org/officeDocument/2006/relationships/hyperlink" Target="file:///G:%5C1111%5CF13FTSNCKF1177_SALybmT%5CF13FTSNCKF1177_SALybmT%5CF13FTSNCKF1177_SALybmT%5Cannotation%5CKEGG%5CAll-Unigene.fa.htm#gene99" TargetMode="External"/><Relationship Id="rId25" Type="http://schemas.openxmlformats.org/officeDocument/2006/relationships/hyperlink" Target="file:///G:%5C1111%5CF13FTSNCKF1177_SALybmT%5CF13FTSNCKF1177_SALybmT%5CF13FTSNCKF1177_SALybmT%5Cannotation%5CKEGG%5CAll-Unigene.fa.htm#gene100" TargetMode="External"/><Relationship Id="rId26" Type="http://schemas.openxmlformats.org/officeDocument/2006/relationships/slideLayout" Target="../slideLayouts/slideLayout13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hyperlink" Target="file:///G:%5C1111%5CF13FTSNCKF1177_SALybmT%5CF13FTSNCKF1177_SALybmT%5CF13FTSNCKF1177_SALybmT%5Cannotation%5CKEGG%5CAll-Unigene.fa.htm#gene101" TargetMode="External"/><Relationship Id="rId2" Type="http://schemas.openxmlformats.org/officeDocument/2006/relationships/hyperlink" Target="file:///G:%5C1111%5CF13FTSNCKF1177_SALybmT%5CF13FTSNCKF1177_SALybmT%5CF13FTSNCKF1177_SALybmT%5Cannotation%5CKEGG%5CAll-Unigene.fa.htm#gene102" TargetMode="External"/><Relationship Id="rId3" Type="http://schemas.openxmlformats.org/officeDocument/2006/relationships/hyperlink" Target="file:///G:%5C1111%5CF13FTSNCKF1177_SALybmT%5CF13FTSNCKF1177_SALybmT%5CF13FTSNCKF1177_SALybmT%5Cannotation%5CKEGG%5CAll-Unigene.fa.htm#gene103" TargetMode="External"/><Relationship Id="rId4" Type="http://schemas.openxmlformats.org/officeDocument/2006/relationships/hyperlink" Target="file:///G:%5C1111%5CF13FTSNCKF1177_SALybmT%5CF13FTSNCKF1177_SALybmT%5CF13FTSNCKF1177_SALybmT%5Cannotation%5CKEGG%5CAll-Unigene.fa.htm#gene104" TargetMode="External"/><Relationship Id="rId5" Type="http://schemas.openxmlformats.org/officeDocument/2006/relationships/hyperlink" Target="file:///G:%5C1111%5CF13FTSNCKF1177_SALybmT%5CF13FTSNCKF1177_SALybmT%5CF13FTSNCKF1177_SALybmT%5Cannotation%5CKEGG%5CAll-Unigene.fa.htm#gene105" TargetMode="External"/><Relationship Id="rId6" Type="http://schemas.openxmlformats.org/officeDocument/2006/relationships/hyperlink" Target="file:///G:%5C1111%5CF13FTSNCKF1177_SALybmT%5CF13FTSNCKF1177_SALybmT%5CF13FTSNCKF1177_SALybmT%5Cannotation%5CKEGG%5CAll-Unigene.fa.htm#gene106" TargetMode="External"/><Relationship Id="rId7" Type="http://schemas.openxmlformats.org/officeDocument/2006/relationships/hyperlink" Target="file:///G:%5C1111%5CF13FTSNCKF1177_SALybmT%5CF13FTSNCKF1177_SALybmT%5CF13FTSNCKF1177_SALybmT%5Cannotation%5CKEGG%5CAll-Unigene.fa.htm#gene107" TargetMode="External"/><Relationship Id="rId8" Type="http://schemas.openxmlformats.org/officeDocument/2006/relationships/hyperlink" Target="file:///G:%5C1111%5CF13FTSNCKF1177_SALybmT%5CF13FTSNCKF1177_SALybmT%5CF13FTSNCKF1177_SALybmT%5Cannotation%5CKEGG%5CAll-Unigene.fa.htm#gene108" TargetMode="External"/><Relationship Id="rId9" Type="http://schemas.openxmlformats.org/officeDocument/2006/relationships/hyperlink" Target="file:///G:%5C1111%5CF13FTSNCKF1177_SALybmT%5CF13FTSNCKF1177_SALybmT%5CF13FTSNCKF1177_SALybmT%5Cannotation%5CKEGG%5CAll-Unigene.fa.htm#gene109" TargetMode="External"/><Relationship Id="rId10" Type="http://schemas.openxmlformats.org/officeDocument/2006/relationships/hyperlink" Target="file:///G:%5C1111%5CF13FTSNCKF1177_SALybmT%5CF13FTSNCKF1177_SALybmT%5CF13FTSNCKF1177_SALybmT%5Cannotation%5CKEGG%5CAll-Unigene.fa.htm#gene110" TargetMode="External"/><Relationship Id="rId11" Type="http://schemas.openxmlformats.org/officeDocument/2006/relationships/hyperlink" Target="file:///G:%5C1111%5CF13FTSNCKF1177_SALybmT%5CF13FTSNCKF1177_SALybmT%5CF13FTSNCKF1177_SALybmT%5Cannotation%5CKEGG%5CAll-Unigene.fa.htm#gene111" TargetMode="External"/><Relationship Id="rId12" Type="http://schemas.openxmlformats.org/officeDocument/2006/relationships/hyperlink" Target="file:///G:%5C1111%5CF13FTSNCKF1177_SALybmT%5CF13FTSNCKF1177_SALybmT%5CF13FTSNCKF1177_SALybmT%5Cannotation%5CKEGG%5CAll-Unigene.fa.htm#gene112" TargetMode="External"/><Relationship Id="rId13" Type="http://schemas.openxmlformats.org/officeDocument/2006/relationships/hyperlink" Target="file:///G:%5C1111%5CF13FTSNCKF1177_SALybmT%5CF13FTSNCKF1177_SALybmT%5CF13FTSNCKF1177_SALybmT%5Cannotation%5CKEGG%5CAll-Unigene.fa.htm#gene113" TargetMode="External"/><Relationship Id="rId14" Type="http://schemas.openxmlformats.org/officeDocument/2006/relationships/hyperlink" Target="file:///G:%5C1111%5CF13FTSNCKF1177_SALybmT%5CF13FTSNCKF1177_SALybmT%5CF13FTSNCKF1177_SALybmT%5Cannotation%5CKEGG%5CAll-Unigene.fa.htm#gene114" TargetMode="External"/><Relationship Id="rId15" Type="http://schemas.openxmlformats.org/officeDocument/2006/relationships/hyperlink" Target="file:///G:%5C1111%5CF13FTSNCKF1177_SALybmT%5CF13FTSNCKF1177_SALybmT%5CF13FTSNCKF1177_SALybmT%5Cannotation%5CKEGG%5CAll-Unigene.fa.htm#gene115" TargetMode="External"/><Relationship Id="rId16" Type="http://schemas.openxmlformats.org/officeDocument/2006/relationships/hyperlink" Target="file:///G:%5C1111%5CF13FTSNCKF1177_SALybmT%5CF13FTSNCKF1177_SALybmT%5CF13FTSNCKF1177_SALybmT%5Cannotation%5CKEGG%5CAll-Unigene.fa.htm#gene116" TargetMode="External"/><Relationship Id="rId17" Type="http://schemas.openxmlformats.org/officeDocument/2006/relationships/hyperlink" Target="file:///G:%5C1111%5CF13FTSNCKF1177_SALybmT%5CF13FTSNCKF1177_SALybmT%5CF13FTSNCKF1177_SALybmT%5Cannotation%5CKEGG%5CAll-Unigene.fa.htm#gene117" TargetMode="External"/><Relationship Id="rId18" Type="http://schemas.openxmlformats.org/officeDocument/2006/relationships/hyperlink" Target="file:///G:%5C1111%5CF13FTSNCKF1177_SALybmT%5CF13FTSNCKF1177_SALybmT%5CF13FTSNCKF1177_SALybmT%5Cannotation%5CKEGG%5CAll-Unigene.fa.htm#gene118" TargetMode="External"/><Relationship Id="rId19" Type="http://schemas.openxmlformats.org/officeDocument/2006/relationships/hyperlink" Target="file:///G:%5C1111%5CF13FTSNCKF1177_SALybmT%5CF13FTSNCKF1177_SALybmT%5CF13FTSNCKF1177_SALybmT%5Cannotation%5CKEGG%5CAll-Unigene.fa.htm#gene119" TargetMode="External"/><Relationship Id="rId20" Type="http://schemas.openxmlformats.org/officeDocument/2006/relationships/hyperlink" Target="file:///G:%5C1111%5CF13FTSNCKF1177_SALybmT%5CF13FTSNCKF1177_SALybmT%5CF13FTSNCKF1177_SALybmT%5Cannotation%5CKEGG%5CAll-Unigene.fa.htm#gene120" TargetMode="External"/><Relationship Id="rId21" Type="http://schemas.openxmlformats.org/officeDocument/2006/relationships/hyperlink" Target="file:///G:%5C1111%5CF13FTSNCKF1177_SALybmT%5CF13FTSNCKF1177_SALybmT%5CF13FTSNCKF1177_SALybmT%5Cannotation%5CKEGG%5CAll-Unigene.fa.htm#gene121" TargetMode="External"/><Relationship Id="rId22" Type="http://schemas.openxmlformats.org/officeDocument/2006/relationships/hyperlink" Target="file:///G:%5C1111%5CF13FTSNCKF1177_SALybmT%5CF13FTSNCKF1177_SALybmT%5CF13FTSNCKF1177_SALybmT%5Cannotation%5CKEGG%5CAll-Unigene.fa.htm#gene122" TargetMode="External"/><Relationship Id="rId23" Type="http://schemas.openxmlformats.org/officeDocument/2006/relationships/hyperlink" Target="file:///G:%5C1111%5CF13FTSNCKF1177_SALybmT%5CF13FTSNCKF1177_SALybmT%5CF13FTSNCKF1177_SALybmT%5Cannotation%5CKEGG%5CAll-Unigene.fa.htm#gene123" TargetMode="External"/><Relationship Id="rId24" Type="http://schemas.openxmlformats.org/officeDocument/2006/relationships/hyperlink" Target="file:///G:%5C1111%5CF13FTSNCKF1177_SALybmT%5CF13FTSNCKF1177_SALybmT%5CF13FTSNCKF1177_SALybmT%5Cannotation%5CKEGG%5CAll-Unigene.fa.htm#gene124" TargetMode="External"/><Relationship Id="rId25" Type="http://schemas.openxmlformats.org/officeDocument/2006/relationships/hyperlink" Target="file:///G:%5C1111%5CF13FTSNCKF1177_SALybmT%5CF13FTSNCKF1177_SALybmT%5CF13FTSNCKF1177_SALybmT%5Cannotation%5CKEGG%5CAll-Unigene.fa.htm#gene125" TargetMode="External"/><Relationship Id="rId26" Type="http://schemas.openxmlformats.org/officeDocument/2006/relationships/hyperlink" Target="file:///G:%5C1111%5CF13FTSNCKF1177_SALybmT%5CF13FTSNCKF1177_SALybmT%5CF13FTSNCKF1177_SALybmT%5Cannotation%5CKEGG%5CAll-Unigene.fa.htm#gene126" TargetMode="External"/><Relationship Id="rId27" Type="http://schemas.openxmlformats.org/officeDocument/2006/relationships/slideLayout" Target="../slideLayouts/slideLayout1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TextBox 3"/>
          <p:cNvSpPr/>
          <p:nvPr/>
        </p:nvSpPr>
        <p:spPr>
          <a:xfrm>
            <a:off x="179280" y="189000"/>
            <a:ext cx="590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6</a:t>
            </a:r>
            <a:r>
              <a:rPr b="0" lang="zh-CN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：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athway annotation of all-unigene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83" name=""/>
          <p:cNvGraphicFramePr/>
          <p:nvPr/>
        </p:nvGraphicFramePr>
        <p:xfrm>
          <a:off x="611280" y="765000"/>
          <a:ext cx="7200720" cy="5848560"/>
        </p:xfrm>
        <a:graphic>
          <a:graphicData uri="http://schemas.openxmlformats.org/drawingml/2006/table">
            <a:tbl>
              <a:tblPr/>
              <a:tblGrid>
                <a:gridCol w="431640"/>
                <a:gridCol w="3384720"/>
                <a:gridCol w="2305080"/>
                <a:gridCol w="1079280"/>
              </a:tblGrid>
              <a:tr h="368640">
                <a:tc>
                  <a:txBody>
                    <a:bodyPr lIns="720" rIns="720" tIns="720" bIns="72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#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athway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ll genes with pathway annotation (23885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athway I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4320"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"/>
                        </a:rPr>
                        <a:t>Metabolic pathway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177 (21.67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11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06360"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2"/>
                        </a:rPr>
                        <a:t>Biosynthesis of secondary metabolit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443 (10.23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11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4840"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3"/>
                        </a:rPr>
                        <a:t>Plant-pathogen interac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68 (6.56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462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2880"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4"/>
                        </a:rPr>
                        <a:t>Plant hormone signal transduc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06 (6.31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407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4320"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5"/>
                        </a:rPr>
                        <a:t>Spliceosom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59 (3.6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304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4320"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6"/>
                        </a:rPr>
                        <a:t>RNA transpor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39 (3.51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301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5400"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7"/>
                        </a:rPr>
                        <a:t>Endocyto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56 (2.75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414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57480"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8"/>
                        </a:rPr>
                        <a:t>Protein processing in endoplasmic reticulu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56 (2.75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414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5600"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9"/>
                        </a:rPr>
                        <a:t>Starch and sucrose metaboli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29 (2.63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5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4320"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0"/>
                        </a:rPr>
                        <a:t>Ribosom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21 (2.6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30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5600"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1"/>
                        </a:rPr>
                        <a:t>Glycerophospholipid metaboli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00 (2.51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56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5760"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2"/>
                        </a:rPr>
                        <a:t>Purine metaboli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65 (2.37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23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7200"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3"/>
                        </a:rPr>
                        <a:t>Pyrimidine metaboli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51 (2.31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24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320"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4"/>
                        </a:rPr>
                        <a:t>Ubiquitin mediated proteoly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87 (2.04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412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9760"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5"/>
                        </a:rPr>
                        <a:t>mRNA surveillance pathway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85 (2.03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301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7200"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6"/>
                        </a:rPr>
                        <a:t>Ether lipid metaboli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53 (1.9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56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5760"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7"/>
                        </a:rPr>
                        <a:t>RNA degrada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5 (1.74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301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7960"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8"/>
                        </a:rPr>
                        <a:t>Phenylpropanoid biosynthe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74 (1.57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94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3240"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9"/>
                        </a:rPr>
                        <a:t>Ribosome biogenesis in eukaryot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40 (1.42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300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4320"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20"/>
                        </a:rPr>
                        <a:t>RNA polymeras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06 (1.28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302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4320"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21"/>
                        </a:rPr>
                        <a:t>ABC transporter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05 (1.28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20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74760"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22"/>
                        </a:rPr>
                        <a:t>Amino sugar and nucleotide sugar metaboli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97 (1.24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52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4840"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23"/>
                        </a:rPr>
                        <a:t>Oxidative phosphoryla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73 (1.14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19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1040"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24"/>
                        </a:rPr>
                        <a:t>Circadian rhythm - plan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72 (1.14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" rIns="720" tIns="720" bIns="72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471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" marR="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4" name=""/>
          <p:cNvGraphicFramePr/>
          <p:nvPr/>
        </p:nvGraphicFramePr>
        <p:xfrm>
          <a:off x="324000" y="620640"/>
          <a:ext cx="7488000" cy="5008680"/>
        </p:xfrm>
        <a:graphic>
          <a:graphicData uri="http://schemas.openxmlformats.org/drawingml/2006/table">
            <a:tbl>
              <a:tblPr/>
              <a:tblGrid>
                <a:gridCol w="576000"/>
                <a:gridCol w="3311640"/>
                <a:gridCol w="1728720"/>
                <a:gridCol w="1871640"/>
              </a:tblGrid>
              <a:tr h="192960"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"/>
                        </a:rPr>
                        <a:t>Pentose and glucuronate interconversion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71 (1.13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04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92960"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2"/>
                        </a:rPr>
                        <a:t>Phagosom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49 (1.04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414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2960"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3"/>
                        </a:rPr>
                        <a:t>Glycolysis / Gluconeogene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42 (1.01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0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2960"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4"/>
                        </a:rPr>
                        <a:t>Phenylalanine metaboli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18 (0.91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36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2960"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5"/>
                        </a:rPr>
                        <a:t>Flavonoid biosynthe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98 (0.83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94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2960"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6"/>
                        </a:rPr>
                        <a:t>Phosphatidylinositol signaling syste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98 (0.83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407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2960"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7"/>
                        </a:rPr>
                        <a:t>Arginine and proline metaboli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88 (0.79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33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2960"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8"/>
                        </a:rPr>
                        <a:t>Pyruvate metaboli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88 (0.79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62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2960"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9"/>
                        </a:rPr>
                        <a:t>Nucleotide excision repai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87 (0.78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342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2960"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0"/>
                        </a:rPr>
                        <a:t>Cysteine and methionine metaboli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83 (0.77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27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2960"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1"/>
                        </a:rPr>
                        <a:t>Stilbenoid, diarylheptanoid and gingerol biosynthe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81 (0.76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94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2960"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2"/>
                        </a:rPr>
                        <a:t>Peroxisom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77 (0.74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414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2960"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3"/>
                        </a:rPr>
                        <a:t>Regulation of autophagy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73 (0.72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414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2960"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4"/>
                        </a:rPr>
                        <a:t>Inositol phosphate metaboli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70 (0.71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56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2960"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5"/>
                        </a:rPr>
                        <a:t>Galactose metaboli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61 (0.67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05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2960"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6"/>
                        </a:rPr>
                        <a:t>Glutathione metaboli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60 (0.67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48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2960"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7"/>
                        </a:rPr>
                        <a:t>Carbon fixation in photosynthetic organism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6 (0.65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7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2960"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8"/>
                        </a:rPr>
                        <a:t>Carotenoid biosynthe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3 (0.64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90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2960"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9"/>
                        </a:rPr>
                        <a:t>Terpenoid backbone biosynthe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2 (0.64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9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2960"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20"/>
                        </a:rPr>
                        <a:t>Ascorbate and aldarate metaboli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9 (0.62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05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2960"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21"/>
                        </a:rPr>
                        <a:t>Cyanoamino acid metaboli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7 (0.62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46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2960"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22"/>
                        </a:rPr>
                        <a:t>Basal transcription factor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6 (0.61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302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2960"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23"/>
                        </a:rPr>
                        <a:t>Homologous recombina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4 (0.6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344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2960"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24"/>
                        </a:rPr>
                        <a:t>Zeatin biosynthe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3 (0.6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90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2960"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25"/>
                        </a:rPr>
                        <a:t>Glycerolipid metaboli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1 (0.59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56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2960"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26"/>
                        </a:rPr>
                        <a:t>Alanine, aspartate and glutamate metaboli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8 (0.58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040" rIns="5040" tIns="5040" bIns="50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25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5" name=""/>
          <p:cNvGraphicFramePr/>
          <p:nvPr/>
        </p:nvGraphicFramePr>
        <p:xfrm>
          <a:off x="826920" y="404640"/>
          <a:ext cx="6470640" cy="6181920"/>
        </p:xfrm>
        <a:graphic>
          <a:graphicData uri="http://schemas.openxmlformats.org/drawingml/2006/table">
            <a:tbl>
              <a:tblPr/>
              <a:tblGrid>
                <a:gridCol w="714600"/>
                <a:gridCol w="2520720"/>
                <a:gridCol w="1617840"/>
                <a:gridCol w="1617480"/>
              </a:tblGrid>
              <a:tr h="198360"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"/>
                        </a:rPr>
                        <a:t>Limonene and pinene degrada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7 (0.57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90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79800"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2"/>
                        </a:rPr>
                        <a:t>Glycine, serine and threonine metaboli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7 (0.57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26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8000"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3"/>
                        </a:rPr>
                        <a:t>Fructose and mannose metaboli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4 (0.56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05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6040"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4"/>
                        </a:rPr>
                        <a:t>Porphyrin and chlorophyll metaboli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0 (0.54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86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8000"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5"/>
                        </a:rPr>
                        <a:t>Other glycan degrada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0 (0.54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51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8000"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6"/>
                        </a:rPr>
                        <a:t>Nitrogen metaboli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8 (0.54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9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8000"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7"/>
                        </a:rPr>
                        <a:t>DNA replica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8 (0.54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303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8000"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8"/>
                        </a:rPr>
                        <a:t>Tyrosine metaboli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7 (0.53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35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6040"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9"/>
                        </a:rPr>
                        <a:t>Natural killer cell mediated cytotoxicity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6 (0.53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465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78360"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0"/>
                        </a:rPr>
                        <a:t>Glycosylphosphatidylinositol(GPI)-anchor biosynthe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4 (0.52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56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79800"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1"/>
                        </a:rPr>
                        <a:t>Glyoxylate and dicarboxylate metaboli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4 (0.52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63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8000"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2"/>
                        </a:rPr>
                        <a:t>Base excision repai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1 (0.51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34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80160"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3"/>
                        </a:rPr>
                        <a:t>Phenylalanine, tyrosine and tryptophan biosynthe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6 (0.49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4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8000"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4"/>
                        </a:rPr>
                        <a:t>alpha-Linolenic acid metaboli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5 (0.48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59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8000"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5"/>
                        </a:rPr>
                        <a:t>Photosynthe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5 (0.48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19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8000"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6"/>
                        </a:rPr>
                        <a:t>Pentose phosphate pathway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3 (0.47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03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8000"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7"/>
                        </a:rPr>
                        <a:t>Proteasom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3 (0.47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305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79800"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8"/>
                        </a:rPr>
                        <a:t>Ubiquinone and other terpenoid-quinone biosynthe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1 (0.46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13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8000"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9"/>
                        </a:rPr>
                        <a:t>Aminoacyl-tRNA biosynthe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0 (0.46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97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8360"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20"/>
                        </a:rPr>
                        <a:t>Mismatch repai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7 (0.45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343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8000"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21"/>
                        </a:rPr>
                        <a:t>Citrate cycle (TCA cycle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5 (0.44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02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8360"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22"/>
                        </a:rPr>
                        <a:t>Fatty acid metaboli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3 (0.43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07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79800"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23"/>
                        </a:rPr>
                        <a:t>SNARE interactions in vesicular transpor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1 (0.42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413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8000"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24"/>
                        </a:rPr>
                        <a:t>Propanoate metaboli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0 (0.42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64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8000"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25"/>
                        </a:rPr>
                        <a:t>Protein expor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9 (0.41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756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306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6" name=""/>
          <p:cNvGraphicFramePr/>
          <p:nvPr/>
        </p:nvGraphicFramePr>
        <p:xfrm>
          <a:off x="684360" y="260280"/>
          <a:ext cx="7513560" cy="6470640"/>
        </p:xfrm>
        <a:graphic>
          <a:graphicData uri="http://schemas.openxmlformats.org/drawingml/2006/table">
            <a:tbl>
              <a:tblPr/>
              <a:tblGrid>
                <a:gridCol w="1877760"/>
                <a:gridCol w="1878120"/>
                <a:gridCol w="1879560"/>
                <a:gridCol w="1878120"/>
              </a:tblGrid>
              <a:tr h="382680"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"/>
                        </a:rPr>
                        <a:t>Flavone and flavonol biosynthe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8 (0.41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94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01600"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2"/>
                        </a:rPr>
                        <a:t>Steroid biosynthe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8 (0.41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1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3"/>
                        </a:rPr>
                        <a:t>N-Glycan biosynthe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6 (0.4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5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4"/>
                        </a:rPr>
                        <a:t>Sphingolipid metaboli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0 (0.38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6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82680"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5"/>
                        </a:rPr>
                        <a:t>Valine, leucine and isoleucine degrada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7 (0.36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28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6"/>
                        </a:rPr>
                        <a:t>beta-Alanine metaboli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5 (0.36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4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84120"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7"/>
                        </a:rPr>
                        <a:t>Cutin, suberine and wax biosynthe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4 (0.35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07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8"/>
                        </a:rPr>
                        <a:t>Diterpenoid biosynthe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2 (0.34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90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9"/>
                        </a:rPr>
                        <a:t>Fatty acid biosynthe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8 (0.33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06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84120"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0"/>
                        </a:rPr>
                        <a:t>Biosynthesis of unsaturated fatty acid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8 (0.33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104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1"/>
                        </a:rPr>
                        <a:t>Tryptophan metaboli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4 (0.31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38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82680"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2"/>
                        </a:rPr>
                        <a:t>Tropane, piperidine and pyridine alkaloid biosynthe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9 (0.29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96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84120"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3"/>
                        </a:rPr>
                        <a:t>Glycosaminoglycan degrada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9 (0.29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53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4"/>
                        </a:rPr>
                        <a:t>Lysine degrada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6 (0.28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3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82680"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5"/>
                        </a:rPr>
                        <a:t>Isoquinoline alkaloid biosynthe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5 (0.27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95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6"/>
                        </a:rPr>
                        <a:t>Sulfur metaboli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9 (0.25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92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7"/>
                        </a:rPr>
                        <a:t>Folate biosynthe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7 (0.24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79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1600"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8"/>
                        </a:rPr>
                        <a:t>Isoflavonoid biosynthe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6 (0.23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94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9"/>
                        </a:rPr>
                        <a:t>Brassinosteroid biosynthe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5 (0.23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90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82680"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20"/>
                        </a:rPr>
                        <a:t>Pantothenate and CoA biosynthe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3 (0.22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77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21"/>
                        </a:rPr>
                        <a:t>Butanoate metaboli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1 (0.21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65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22"/>
                        </a:rPr>
                        <a:t>Riboflavin metaboli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1 (0.21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74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1600"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23"/>
                        </a:rPr>
                        <a:t>One carbon pool by folat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8 (0.2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67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24"/>
                        </a:rPr>
                        <a:t>Fatty acid elonga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6 (0.19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06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25"/>
                        </a:rPr>
                        <a:t>Selenocompound metaboli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5 (0.19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864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45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7" name=""/>
          <p:cNvGraphicFramePr/>
          <p:nvPr/>
        </p:nvGraphicFramePr>
        <p:xfrm>
          <a:off x="1332000" y="236520"/>
          <a:ext cx="6234120" cy="6251760"/>
        </p:xfrm>
        <a:graphic>
          <a:graphicData uri="http://schemas.openxmlformats.org/drawingml/2006/table">
            <a:tbl>
              <a:tblPr/>
              <a:tblGrid>
                <a:gridCol w="431640"/>
                <a:gridCol w="2685960"/>
                <a:gridCol w="1557360"/>
                <a:gridCol w="1559160"/>
              </a:tblGrid>
              <a:tr h="379080"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"/>
                        </a:rPr>
                        <a:t>Sesquiterpenoid and triterpenoid biosynthe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5 (0.19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90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98360"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2"/>
                        </a:rPr>
                        <a:t>Histidine metaboli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5 (0.19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34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7280"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3"/>
                        </a:rPr>
                        <a:t>Benzoxazinoid biosynthe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5 (0.19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40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7280"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4"/>
                        </a:rPr>
                        <a:t>Non-homologous end-joinin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5 (0.19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345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6680"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5"/>
                        </a:rPr>
                        <a:t>Nicotinate and nicotinamide metaboli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4 (0.18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76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7280"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6"/>
                        </a:rPr>
                        <a:t>Circadian rhythm - mamma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3 (0.18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47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8360"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7"/>
                        </a:rPr>
                        <a:t>Arachidonic acid metaboli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6 (0.15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59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7280"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8"/>
                        </a:rPr>
                        <a:t>Other types of O-glycan biosynthe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6 (0.15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51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6680"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9"/>
                        </a:rPr>
                        <a:t>Valine, leucine and isoleucine biosynthe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6 (0.15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29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79080"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0"/>
                        </a:rPr>
                        <a:t>Glycosphingolipid biosynthesis - ganglio seri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3 (0.14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60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7280"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1"/>
                        </a:rPr>
                        <a:t>Linoleic acid metaboli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1 (0.13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59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8360"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2"/>
                        </a:rPr>
                        <a:t>Lysine biosynthe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1 (0.13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3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7280"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3"/>
                        </a:rPr>
                        <a:t>Glucosinolate biosynthe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0 (0.13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96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7280"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4"/>
                        </a:rPr>
                        <a:t>Photosynthesis - antenna protein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9 (0.12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19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8360"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5"/>
                        </a:rPr>
                        <a:t>Taurine and hypotaurine metaboli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6 (0.11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43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7280"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6"/>
                        </a:rPr>
                        <a:t>Thiamine metaboli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6 (0.11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73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7280"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7"/>
                        </a:rPr>
                        <a:t>Vitamin B6 metaboli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3 (0.1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75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8360"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8"/>
                        </a:rPr>
                        <a:t>Sulfur relay syste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2 (0.09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412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7280"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19"/>
                        </a:rPr>
                        <a:t>Anthocyanin biosynthe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9 (0.08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94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79080"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20"/>
                        </a:rPr>
                        <a:t>Glycosphingolipid biosynthesis - globo seri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8 (0.08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60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8360"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21"/>
                        </a:rPr>
                        <a:t>Indole alkaloid biosynthe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7 (0.07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9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5240"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22"/>
                        </a:rPr>
                        <a:t>Synthesis and degradation of ketone bodi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 (0.05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07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8360"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23"/>
                        </a:rPr>
                        <a:t>Biotin metaboli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 (0.04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78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7280"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24"/>
                        </a:rPr>
                        <a:t>Betalain biosynthe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 (0.04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96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7280"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25"/>
                        </a:rPr>
                        <a:t>Lipoic acid metaboli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 (0.03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78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7280"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  <a:hlinkClick r:id="rId26"/>
                        </a:rPr>
                        <a:t>Monoterpenoid biosynthe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 (0.03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90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8360"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</a:rPr>
                        <a:t>C5-Branched dibasic acid metaboli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 (0.03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66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7280"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ff"/>
                          </a:solidFill>
                          <a:uFillTx/>
                          <a:latin typeface="Times New Roman"/>
                        </a:rPr>
                        <a:t>Caffeine metaboli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 (0.01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72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0023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0-15T07:15:08Z</dcterms:created>
  <dc:creator>Lee</dc:creator>
  <dc:description/>
  <dc:language>en-US</dc:language>
  <cp:lastModifiedBy>L L</cp:lastModifiedBy>
  <dcterms:modified xsi:type="dcterms:W3CDTF">2015-05-28T04:38:24Z</dcterms:modified>
  <cp:revision>3</cp:revision>
  <dc:subject/>
  <dc:title>PowerPoint Presentation</dc:title>
</cp:coreProperties>
</file>